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heme/theme2.xml" ContentType="application/vnd.openxmlformats-officedocument.theme+xml"/>
  <Override PartName="/ppt/tags/tag63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413" r:id="rId2"/>
  </p:sldIdLst>
  <p:sldSz cx="17999075" cy="1187926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83">
          <p15:clr>
            <a:srgbClr val="A4A3A4"/>
          </p15:clr>
        </p15:guide>
        <p15:guide id="2" pos="5724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50" d="100"/>
          <a:sy n="50" d="100"/>
        </p:scale>
        <p:origin x="1075" y="43"/>
      </p:cViewPr>
      <p:guideLst>
        <p:guide orient="horz" pos="3783"/>
        <p:guide pos="5724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091045" y="1143000"/>
            <a:ext cx="4675909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1090613" y="1143000"/>
            <a:ext cx="4676775" cy="30861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1769997" y="1584132"/>
            <a:ext cx="14468256" cy="4453033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10395" b="1" i="0" spc="30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1769997" y="6168138"/>
            <a:ext cx="14468256" cy="2550827"/>
          </a:xfrm>
        </p:spPr>
        <p:txBody>
          <a:bodyPr lIns="90000" tIns="46800" rIns="90000" bIns="46800">
            <a:normAutofit/>
          </a:bodyPr>
          <a:lstStyle>
            <a:lvl1pPr marL="0" indent="0" algn="ctr" eaLnBrk="1" fontAlgn="auto" latinLnBrk="0" hangingPunct="1">
              <a:lnSpc>
                <a:spcPct val="110000"/>
              </a:lnSpc>
              <a:buNone/>
              <a:defRPr sz="416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791845" indent="0" algn="ctr">
              <a:buNone/>
              <a:defRPr sz="3465"/>
            </a:lvl2pPr>
            <a:lvl3pPr marL="1584325" indent="0" algn="ctr">
              <a:buNone/>
              <a:defRPr sz="3120"/>
            </a:lvl3pPr>
            <a:lvl4pPr marL="2376170" indent="0" algn="ctr">
              <a:buNone/>
              <a:defRPr sz="2770"/>
            </a:lvl4pPr>
            <a:lvl5pPr marL="3169285" indent="0" algn="ctr">
              <a:buNone/>
              <a:defRPr sz="2770"/>
            </a:lvl5pPr>
            <a:lvl6pPr marL="3959860" indent="0" algn="ctr">
              <a:buNone/>
              <a:defRPr sz="2770"/>
            </a:lvl6pPr>
            <a:lvl7pPr marL="4752340" indent="0" algn="ctr">
              <a:buNone/>
              <a:defRPr sz="2770"/>
            </a:lvl7pPr>
            <a:lvl8pPr marL="5544185" indent="0" algn="ctr">
              <a:buNone/>
              <a:defRPr sz="2770"/>
            </a:lvl8pPr>
            <a:lvl9pPr marL="6336665" indent="0" algn="ctr">
              <a:buNone/>
              <a:defRPr sz="277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898286" y="1340900"/>
            <a:ext cx="16201045" cy="9498557"/>
          </a:xfrm>
        </p:spPr>
        <p:txBody>
          <a:bodyPr/>
          <a:lstStyle>
            <a:lvl1pPr marL="396240" indent="-396240" eaLnBrk="1" fontAlgn="auto" latinLnBrk="0" hangingPunct="1">
              <a:lnSpc>
                <a:spcPct val="13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1188085" indent="-39624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980565" indent="-39624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2772410" indent="-39624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3563620" indent="-39624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769997" y="4303352"/>
            <a:ext cx="14468256" cy="1764998"/>
          </a:xfrm>
        </p:spPr>
        <p:txBody>
          <a:bodyPr vert="horz" lIns="90000" tIns="46800" rIns="90000" bIns="46800" rtlCol="0" anchor="t" anchorCtr="0">
            <a:norm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10395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769997" y="6168138"/>
            <a:ext cx="14468256" cy="817013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4160" spc="2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898286" y="1054009"/>
            <a:ext cx="16195730" cy="1222401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6235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898286" y="2582011"/>
            <a:ext cx="16195730" cy="8244972"/>
          </a:xfrm>
        </p:spPr>
        <p:txBody>
          <a:bodyPr vert="horz" lIns="90000" tIns="46800" rIns="90000" bIns="46800" rtlCol="0">
            <a:normAutofit/>
          </a:bodyPr>
          <a:lstStyle>
            <a:lvl1pPr marL="396240" marR="0" lvl="0" indent="-396240" algn="l" defTabSz="914400" rtl="0" eaLnBrk="1" fontAlgn="auto" latinLnBrk="0" hangingPunct="1">
              <a:lnSpc>
                <a:spcPct val="130000"/>
              </a:lnSpc>
              <a:spcBef>
                <a:spcPct val="1000"/>
              </a:spcBef>
              <a:spcAft>
                <a:spcPts val="1000"/>
              </a:spcAft>
              <a:buFont typeface="Arial" panose="020B0604020202020204" pitchFamily="34" charset="0"/>
              <a:buChar char="●"/>
              <a:defRPr kumimoji="0" lang="zh-CN" altLang="en-US" sz="312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1188085" marR="0" lvl="1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980565" marR="0" lvl="2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2772410" marR="0" lvl="3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2425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3563620" marR="0" lvl="4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2425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  <a:lvl6pPr marL="3959860" indent="0">
              <a:buNone/>
              <a:defRPr/>
            </a:lvl6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2939362" y="6667077"/>
            <a:ext cx="11470425" cy="1328426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7620" b="1" i="0" u="none" strike="noStrike" kern="1200" cap="none" spc="300" normalizeH="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2939362" y="7995502"/>
            <a:ext cx="11470425" cy="1503054"/>
          </a:xfrm>
        </p:spPr>
        <p:txBody>
          <a:bodyPr lIns="90000" tIns="46800" rIns="90000" bIns="46800">
            <a:normAutofit/>
          </a:bodyPr>
          <a:lstStyle>
            <a:lvl1pPr marL="0" indent="0" eaLnBrk="1" fontAlgn="auto" latinLnBrk="0" hangingPunct="1">
              <a:lnSpc>
                <a:spcPct val="130000"/>
              </a:lnSpc>
              <a:buNone/>
              <a:defRPr kumimoji="0" lang="zh-CN" altLang="en-US" sz="3120" b="0" i="0" u="none" strike="noStrike" kern="1200" cap="none" spc="150" normalizeH="0" baseline="0" noProof="1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791845" indent="0">
              <a:buNone/>
              <a:defRPr sz="3465">
                <a:solidFill>
                  <a:schemeClr val="tx1">
                    <a:tint val="75000"/>
                  </a:schemeClr>
                </a:solidFill>
              </a:defRPr>
            </a:lvl2pPr>
            <a:lvl3pPr marL="1584325" indent="0">
              <a:buNone/>
              <a:defRPr sz="3120">
                <a:solidFill>
                  <a:schemeClr val="tx1">
                    <a:tint val="75000"/>
                  </a:schemeClr>
                </a:solidFill>
              </a:defRPr>
            </a:lvl3pPr>
            <a:lvl4pPr marL="2376170" indent="0">
              <a:buNone/>
              <a:defRPr sz="2770">
                <a:solidFill>
                  <a:schemeClr val="tx1">
                    <a:tint val="75000"/>
                  </a:schemeClr>
                </a:solidFill>
              </a:defRPr>
            </a:lvl4pPr>
            <a:lvl5pPr marL="3169285" indent="0">
              <a:buNone/>
              <a:defRPr sz="2770">
                <a:solidFill>
                  <a:schemeClr val="tx1">
                    <a:tint val="75000"/>
                  </a:schemeClr>
                </a:solidFill>
              </a:defRPr>
            </a:lvl5pPr>
            <a:lvl6pPr marL="3959860" indent="0">
              <a:buNone/>
              <a:defRPr sz="2770">
                <a:solidFill>
                  <a:schemeClr val="tx1">
                    <a:tint val="75000"/>
                  </a:schemeClr>
                </a:solidFill>
              </a:defRPr>
            </a:lvl6pPr>
            <a:lvl7pPr marL="4752340" indent="0">
              <a:buNone/>
              <a:defRPr sz="2770">
                <a:solidFill>
                  <a:schemeClr val="tx1">
                    <a:tint val="75000"/>
                  </a:schemeClr>
                </a:solidFill>
              </a:defRPr>
            </a:lvl7pPr>
            <a:lvl8pPr marL="5544185" indent="0">
              <a:buNone/>
              <a:defRPr sz="2770">
                <a:solidFill>
                  <a:schemeClr val="tx1">
                    <a:tint val="75000"/>
                  </a:schemeClr>
                </a:solidFill>
              </a:defRPr>
            </a:lvl8pPr>
            <a:lvl9pPr marL="6336665" indent="0">
              <a:buNone/>
              <a:defRPr sz="27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898286" y="1054009"/>
            <a:ext cx="16195730" cy="1222401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6235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898286" y="2600722"/>
            <a:ext cx="7643406" cy="8226262"/>
          </a:xfrm>
        </p:spPr>
        <p:txBody>
          <a:bodyPr vert="horz" lIns="90000" tIns="46800" rIns="90000" bIns="46800" rtlCol="0">
            <a:normAutofit/>
          </a:bodyPr>
          <a:lstStyle>
            <a:lvl1pPr marL="396240" marR="0" lvl="0" indent="-396240" algn="l" defTabSz="914400" rtl="0" eaLnBrk="1" fontAlgn="auto" latinLnBrk="0" hangingPunct="1">
              <a:lnSpc>
                <a:spcPct val="13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1188085" marR="0" lvl="1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980565" marR="0" lvl="2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2772410" marR="0" lvl="3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2425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3563620" marR="0" lvl="4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2425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9466556" y="2600722"/>
            <a:ext cx="7643406" cy="8226262"/>
          </a:xfrm>
        </p:spPr>
        <p:txBody>
          <a:bodyPr lIns="90000" tIns="46800" rIns="90000" bIns="46800">
            <a:normAutofit/>
          </a:bodyPr>
          <a:lstStyle>
            <a:lvl1pPr marL="396240" indent="-396240" eaLnBrk="1" fontAlgn="auto" latinLnBrk="0" hangingPunct="1">
              <a:lnSpc>
                <a:spcPct val="13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sz="277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1188085" indent="-39624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sz="277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980565" indent="-39624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sz="277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2772410" indent="-39624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sz="2425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lnSpc>
                <a:spcPct val="120000"/>
              </a:lnSpc>
              <a:defRPr sz="2425"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898286" y="1054009"/>
            <a:ext cx="16195730" cy="1222401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6235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898286" y="2475986"/>
            <a:ext cx="7887910" cy="661094"/>
          </a:xfrm>
        </p:spPr>
        <p:txBody>
          <a:bodyPr lIns="101600" tIns="38100" rIns="76200" bIns="38100" anchor="t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3465" b="1" u="none" strike="noStrike" kern="1200" cap="none" spc="200" normalizeH="0" baseline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91845" indent="0">
              <a:buNone/>
              <a:defRPr sz="3465" b="1"/>
            </a:lvl2pPr>
            <a:lvl3pPr marL="1584325" indent="0">
              <a:buNone/>
              <a:defRPr sz="3120" b="1"/>
            </a:lvl3pPr>
            <a:lvl4pPr marL="2376170" indent="0">
              <a:buNone/>
              <a:defRPr sz="2770" b="1"/>
            </a:lvl4pPr>
            <a:lvl5pPr marL="3169285" indent="0">
              <a:buNone/>
              <a:defRPr sz="2770" b="1"/>
            </a:lvl5pPr>
            <a:lvl6pPr marL="3959860" indent="0">
              <a:buNone/>
              <a:defRPr sz="2770" b="1"/>
            </a:lvl6pPr>
            <a:lvl7pPr marL="4752340" indent="0">
              <a:buNone/>
              <a:defRPr sz="2770" b="1"/>
            </a:lvl7pPr>
            <a:lvl8pPr marL="5544185" indent="0">
              <a:buNone/>
              <a:defRPr sz="2770" b="1"/>
            </a:lvl8pPr>
            <a:lvl9pPr marL="6336665" indent="0">
              <a:buNone/>
              <a:defRPr sz="277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898286" y="3211922"/>
            <a:ext cx="7887910" cy="7615062"/>
          </a:xfrm>
        </p:spPr>
        <p:txBody>
          <a:bodyPr vert="horz" lIns="101600" tIns="0" rIns="82550" bIns="0" rtlCol="0">
            <a:normAutofit/>
          </a:bodyPr>
          <a:lstStyle>
            <a:lvl1pPr marL="396240" marR="0" lvl="0" indent="-396240" algn="l" defTabSz="914400" rtl="0" eaLnBrk="1" fontAlgn="auto" latinLnBrk="0" hangingPunct="1">
              <a:lnSpc>
                <a:spcPct val="13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1188085" marR="0" lvl="1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980565" marR="0" lvl="2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2772410" marR="0" lvl="3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2425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3563620" marR="0" lvl="4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2425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9206917" y="2463043"/>
            <a:ext cx="7887910" cy="661094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100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3465" b="1" i="0" u="none" strike="noStrike" kern="1200" cap="none" spc="20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791845" indent="0">
              <a:buNone/>
              <a:defRPr sz="3465" b="1"/>
            </a:lvl2pPr>
            <a:lvl3pPr marL="1584325" indent="0">
              <a:buNone/>
              <a:defRPr sz="3120" b="1"/>
            </a:lvl3pPr>
            <a:lvl4pPr marL="2376170" indent="0">
              <a:buNone/>
              <a:defRPr sz="2770" b="1"/>
            </a:lvl4pPr>
            <a:lvl5pPr marL="3169285" indent="0">
              <a:buNone/>
              <a:defRPr sz="2770" b="1"/>
            </a:lvl5pPr>
            <a:lvl6pPr marL="3959860" indent="0">
              <a:buNone/>
              <a:defRPr sz="2770" b="1"/>
            </a:lvl6pPr>
            <a:lvl7pPr marL="4752340" indent="0">
              <a:buNone/>
              <a:defRPr sz="2770" b="1"/>
            </a:lvl7pPr>
            <a:lvl8pPr marL="5544185" indent="0">
              <a:buNone/>
              <a:defRPr sz="2770" b="1"/>
            </a:lvl8pPr>
            <a:lvl9pPr marL="6336665" indent="0">
              <a:buNone/>
              <a:defRPr sz="277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9206917" y="3211922"/>
            <a:ext cx="7887910" cy="7615062"/>
          </a:xfrm>
        </p:spPr>
        <p:txBody>
          <a:bodyPr vert="horz" lIns="101600" tIns="0" rIns="82550" bIns="0" rtlCol="0">
            <a:normAutofit/>
          </a:bodyPr>
          <a:lstStyle>
            <a:lvl1pPr marL="396240" marR="0" lvl="0" indent="-396240" algn="l" defTabSz="914400" rtl="0" eaLnBrk="1" fontAlgn="auto" latinLnBrk="0" hangingPunct="1">
              <a:lnSpc>
                <a:spcPct val="13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1188085" marR="0" lvl="1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980565" marR="0" lvl="2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2772410" marR="0" lvl="3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2425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3563620" marR="0" lvl="4" indent="-396240" algn="l" defTabSz="914400" rtl="0" eaLnBrk="1" fontAlgn="auto" latinLnBrk="0" hangingPunct="1">
              <a:lnSpc>
                <a:spcPct val="120000"/>
              </a:lnSpc>
              <a:spcBef>
                <a:spcPct val="100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2425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898286" y="1054009"/>
            <a:ext cx="16195730" cy="1222401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6235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898286" y="2694273"/>
            <a:ext cx="7726498" cy="7983029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ct val="100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2770" b="0" i="0" u="none" strike="noStrike" kern="1200" cap="none" spc="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1188085" marR="0" lvl="1" indent="-396240" algn="l" defTabSz="914400" rtl="0" eaLnBrk="1" fontAlgn="auto" latinLnBrk="0" hangingPunct="1">
              <a:lnSpc>
                <a:spcPct val="130000"/>
              </a:lnSpc>
              <a:spcBef>
                <a:spcPct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277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980565" marR="0" lvl="2" indent="-396240" algn="l" defTabSz="914400" rtl="0" eaLnBrk="1" fontAlgn="auto" latinLnBrk="0" hangingPunct="1">
              <a:lnSpc>
                <a:spcPct val="130000"/>
              </a:lnSpc>
              <a:spcBef>
                <a:spcPct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277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2772410" marR="0" lvl="3" indent="-396240" algn="l" defTabSz="914400" rtl="0" eaLnBrk="1" fontAlgn="auto" latinLnBrk="0" hangingPunct="1">
              <a:lnSpc>
                <a:spcPct val="130000"/>
              </a:lnSpc>
              <a:spcBef>
                <a:spcPct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277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3563620" marR="0" lvl="4" indent="-396240" algn="l" defTabSz="914400" rtl="0" eaLnBrk="1" fontAlgn="auto" latinLnBrk="0" hangingPunct="1">
              <a:lnSpc>
                <a:spcPct val="130000"/>
              </a:lnSpc>
              <a:spcBef>
                <a:spcPct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277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9376195" y="2694273"/>
            <a:ext cx="7717820" cy="7983029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ct val="1000"/>
              </a:spcBef>
              <a:spcAft>
                <a:spcPts val="600"/>
              </a:spcAft>
              <a:buFont typeface="Arial" panose="020B0604020202020204" pitchFamily="34" charset="0"/>
              <a:buNone/>
              <a:defRPr kumimoji="0" lang="zh-CN" altLang="en-US" sz="277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791845" indent="0" defTabSz="914400" eaLnBrk="1" fontAlgn="auto" latinLnBrk="0" hangingPunct="1">
              <a:buFont typeface="Arial" panose="020B060402020202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eaLnBrk="1" fontAlgn="auto" latinLnBrk="0" hangingPunct="1">
              <a:buFont typeface="Arial" panose="020B0604020202020204" pitchFamily="34" charset="0"/>
              <a:buChar char="●"/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1/12/12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5111408" y="1584132"/>
            <a:ext cx="1541438" cy="8712728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485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1350087" y="1584132"/>
            <a:ext cx="13538078" cy="8712728"/>
          </a:xfrm>
        </p:spPr>
        <p:txBody>
          <a:bodyPr vert="eaVert" lIns="46800" tIns="46800" rIns="46800" bIns="46800"/>
          <a:lstStyle>
            <a:lvl1pPr marL="396240" indent="-396240" eaLnBrk="1" fontAlgn="auto" latinLnBrk="0" hangingPunct="1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1188085" indent="-396240" defTabSz="9144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980565" indent="-39624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2772410" indent="-396240" eaLnBrk="1" fontAlgn="auto" latinLnBrk="0" hangingPunct="1">
              <a:lnSpc>
                <a:spcPct val="120000"/>
              </a:lnSpc>
              <a:spcAft>
                <a:spcPts val="300"/>
              </a:spcAft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3563620" indent="-396240" eaLnBrk="1" fontAlgn="auto" latinLnBrk="0" hangingPunct="1">
              <a:lnSpc>
                <a:spcPct val="120000"/>
              </a:lnSpc>
              <a:spcAft>
                <a:spcPts val="300"/>
              </a:spcAft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898286" y="1054009"/>
            <a:ext cx="16195730" cy="1222401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898286" y="2582011"/>
            <a:ext cx="16195730" cy="8244972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903602" y="10939244"/>
            <a:ext cx="3986477" cy="5488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725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  <a:t>2021/1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6077164" y="10939244"/>
            <a:ext cx="5846834" cy="5488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725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13107538" y="10939244"/>
            <a:ext cx="3986477" cy="5488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725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584325" rtl="0" eaLnBrk="1" fontAlgn="auto" latinLnBrk="0" hangingPunct="1">
        <a:lnSpc>
          <a:spcPct val="100000"/>
        </a:lnSpc>
        <a:spcBef>
          <a:spcPct val="0"/>
        </a:spcBef>
        <a:buNone/>
        <a:defRPr sz="6235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396240" indent="-396240" algn="l" defTabSz="1584325" rtl="0" eaLnBrk="1" fontAlgn="auto" latinLnBrk="0" hangingPunct="1">
        <a:lnSpc>
          <a:spcPct val="130000"/>
        </a:lnSpc>
        <a:spcBef>
          <a:spcPct val="1000"/>
        </a:spcBef>
        <a:spcAft>
          <a:spcPts val="1000"/>
        </a:spcAft>
        <a:buFont typeface="Arial" panose="020B0604020202020204" pitchFamily="34" charset="0"/>
        <a:buChar char="●"/>
        <a:defRPr sz="312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1188085" indent="-396240" algn="l" defTabSz="1584325" rtl="0" eaLnBrk="1" fontAlgn="auto" latinLnBrk="0" hangingPunct="1">
        <a:lnSpc>
          <a:spcPct val="120000"/>
        </a:lnSpc>
        <a:spcBef>
          <a:spcPct val="1000"/>
        </a:spcBef>
        <a:spcAft>
          <a:spcPts val="600"/>
        </a:spcAft>
        <a:buFont typeface="Arial" panose="020B0604020202020204" pitchFamily="34" charset="0"/>
        <a:buChar char="●"/>
        <a:tabLst>
          <a:tab pos="2788285" algn="l"/>
          <a:tab pos="2788285" algn="l"/>
          <a:tab pos="2788285" algn="l"/>
          <a:tab pos="2788285" algn="l"/>
        </a:tabLst>
        <a:defRPr sz="277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980565" indent="-396240" algn="l" defTabSz="1584325" rtl="0" eaLnBrk="1" fontAlgn="auto" latinLnBrk="0" hangingPunct="1">
        <a:lnSpc>
          <a:spcPct val="120000"/>
        </a:lnSpc>
        <a:spcBef>
          <a:spcPct val="1000"/>
        </a:spcBef>
        <a:spcAft>
          <a:spcPts val="600"/>
        </a:spcAft>
        <a:buFont typeface="Arial" panose="020B0604020202020204" pitchFamily="34" charset="0"/>
        <a:buChar char="●"/>
        <a:defRPr sz="277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2772410" indent="-396240" algn="l" defTabSz="1584325" rtl="0" eaLnBrk="1" fontAlgn="auto" latinLnBrk="0" hangingPunct="1">
        <a:lnSpc>
          <a:spcPct val="120000"/>
        </a:lnSpc>
        <a:spcBef>
          <a:spcPct val="1000"/>
        </a:spcBef>
        <a:spcAft>
          <a:spcPts val="300"/>
        </a:spcAft>
        <a:buFont typeface="Wingdings" panose="05000000000000000000" charset="0"/>
        <a:buChar char=""/>
        <a:defRPr sz="242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3563620" indent="-396240" algn="l" defTabSz="1584325" rtl="0" eaLnBrk="1" fontAlgn="auto" latinLnBrk="0" hangingPunct="1">
        <a:lnSpc>
          <a:spcPct val="120000"/>
        </a:lnSpc>
        <a:spcBef>
          <a:spcPct val="1000"/>
        </a:spcBef>
        <a:spcAft>
          <a:spcPts val="300"/>
        </a:spcAft>
        <a:buFont typeface="Arial" panose="020B0604020202020204" pitchFamily="34" charset="0"/>
        <a:buChar char="•"/>
        <a:defRPr sz="242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4356100" indent="-396240" algn="l" defTabSz="1584325" rtl="0" eaLnBrk="1" latinLnBrk="0" hangingPunct="1">
        <a:lnSpc>
          <a:spcPct val="90000"/>
        </a:lnSpc>
        <a:spcBef>
          <a:spcPts val="865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6pPr>
      <a:lvl7pPr marL="5147945" indent="-396240" algn="l" defTabSz="1584325" rtl="0" eaLnBrk="1" latinLnBrk="0" hangingPunct="1">
        <a:lnSpc>
          <a:spcPct val="90000"/>
        </a:lnSpc>
        <a:spcBef>
          <a:spcPts val="865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7pPr>
      <a:lvl8pPr marL="5941060" indent="-396240" algn="l" defTabSz="1584325" rtl="0" eaLnBrk="1" latinLnBrk="0" hangingPunct="1">
        <a:lnSpc>
          <a:spcPct val="90000"/>
        </a:lnSpc>
        <a:spcBef>
          <a:spcPts val="865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8pPr>
      <a:lvl9pPr marL="6732270" indent="-396240" algn="l" defTabSz="1584325" rtl="0" eaLnBrk="1" latinLnBrk="0" hangingPunct="1">
        <a:lnSpc>
          <a:spcPct val="90000"/>
        </a:lnSpc>
        <a:spcBef>
          <a:spcPts val="865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584325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1pPr>
      <a:lvl2pPr marL="791845" algn="l" defTabSz="1584325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2pPr>
      <a:lvl3pPr marL="1584325" algn="l" defTabSz="1584325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3pPr>
      <a:lvl4pPr marL="2376170" algn="l" defTabSz="1584325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4pPr>
      <a:lvl5pPr marL="3169285" algn="l" defTabSz="1584325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5pPr>
      <a:lvl6pPr marL="3959860" algn="l" defTabSz="1584325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6pPr>
      <a:lvl7pPr marL="4752340" algn="l" defTabSz="1584325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7pPr>
      <a:lvl8pPr marL="5544185" algn="l" defTabSz="1584325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8pPr>
      <a:lvl9pPr marL="6336665" algn="l" defTabSz="1584325" rtl="0" eaLnBrk="1" latinLnBrk="0" hangingPunct="1">
        <a:defRPr sz="31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10.jpeg"/><Relationship Id="rId18" Type="http://schemas.openxmlformats.org/officeDocument/2006/relationships/image" Target="../media/image15.jpeg"/><Relationship Id="rId26" Type="http://schemas.openxmlformats.org/officeDocument/2006/relationships/image" Target="../media/image23.jpeg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18.jpeg"/><Relationship Id="rId7" Type="http://schemas.openxmlformats.org/officeDocument/2006/relationships/image" Target="../media/image4.jpeg"/><Relationship Id="rId12" Type="http://schemas.openxmlformats.org/officeDocument/2006/relationships/image" Target="../media/image9.jpeg"/><Relationship Id="rId17" Type="http://schemas.openxmlformats.org/officeDocument/2006/relationships/image" Target="../media/image14.jpeg"/><Relationship Id="rId25" Type="http://schemas.openxmlformats.org/officeDocument/2006/relationships/image" Target="../media/image22.jpe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3.jpeg"/><Relationship Id="rId20" Type="http://schemas.openxmlformats.org/officeDocument/2006/relationships/image" Target="../media/image17.jpeg"/><Relationship Id="rId29" Type="http://schemas.openxmlformats.org/officeDocument/2006/relationships/image" Target="../media/image26.jpeg"/><Relationship Id="rId1" Type="http://schemas.openxmlformats.org/officeDocument/2006/relationships/tags" Target="../tags/tag63.xml"/><Relationship Id="rId6" Type="http://schemas.openxmlformats.org/officeDocument/2006/relationships/image" Target="../media/image3.jpeg"/><Relationship Id="rId11" Type="http://schemas.openxmlformats.org/officeDocument/2006/relationships/image" Target="../media/image8.jpeg"/><Relationship Id="rId24" Type="http://schemas.openxmlformats.org/officeDocument/2006/relationships/image" Target="../media/image21.jpeg"/><Relationship Id="rId5" Type="http://schemas.openxmlformats.org/officeDocument/2006/relationships/image" Target="../media/image2.jpeg"/><Relationship Id="rId15" Type="http://schemas.openxmlformats.org/officeDocument/2006/relationships/image" Target="../media/image12.jpeg"/><Relationship Id="rId23" Type="http://schemas.openxmlformats.org/officeDocument/2006/relationships/image" Target="../media/image20.jpeg"/><Relationship Id="rId28" Type="http://schemas.openxmlformats.org/officeDocument/2006/relationships/image" Target="../media/image25.jpeg"/><Relationship Id="rId10" Type="http://schemas.openxmlformats.org/officeDocument/2006/relationships/image" Target="../media/image7.jpeg"/><Relationship Id="rId19" Type="http://schemas.openxmlformats.org/officeDocument/2006/relationships/image" Target="../media/image16.jpeg"/><Relationship Id="rId31" Type="http://schemas.openxmlformats.org/officeDocument/2006/relationships/image" Target="../media/image28.jpeg"/><Relationship Id="rId4" Type="http://schemas.openxmlformats.org/officeDocument/2006/relationships/image" Target="../media/image1.jpeg"/><Relationship Id="rId9" Type="http://schemas.openxmlformats.org/officeDocument/2006/relationships/image" Target="../media/image6.jpeg"/><Relationship Id="rId14" Type="http://schemas.openxmlformats.org/officeDocument/2006/relationships/image" Target="../media/image11.jpeg"/><Relationship Id="rId22" Type="http://schemas.openxmlformats.org/officeDocument/2006/relationships/image" Target="../media/image19.jpeg"/><Relationship Id="rId27" Type="http://schemas.openxmlformats.org/officeDocument/2006/relationships/image" Target="../media/image24.jpeg"/><Relationship Id="rId30" Type="http://schemas.openxmlformats.org/officeDocument/2006/relationships/image" Target="../media/image2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531136" y="2467167"/>
            <a:ext cx="1768419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A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gc)</a:t>
            </a:r>
          </a:p>
        </p:txBody>
      </p:sp>
      <p:pic>
        <p:nvPicPr>
          <p:cNvPr id="3" name="图片 2" descr="trnA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30300" y="131445"/>
            <a:ext cx="2169160" cy="2335530"/>
          </a:xfrm>
          <a:prstGeom prst="rect">
            <a:avLst/>
          </a:prstGeom>
        </p:spPr>
      </p:pic>
      <p:pic>
        <p:nvPicPr>
          <p:cNvPr id="4" name="图片 3" descr="trnC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99674" y="132954"/>
            <a:ext cx="2170800" cy="2337622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829201" y="2469072"/>
            <a:ext cx="1768419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rnC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(gca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)</a:t>
            </a:r>
          </a:p>
        </p:txBody>
      </p:sp>
      <p:pic>
        <p:nvPicPr>
          <p:cNvPr id="6" name="图片 5" descr="trnD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61840" y="131434"/>
            <a:ext cx="2170800" cy="2337622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6010275" y="2466975"/>
            <a:ext cx="12611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rnD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(gtc)</a:t>
            </a:r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8" name="图片 7" descr="trnE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02147" y="129773"/>
            <a:ext cx="2169907" cy="233640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8208161" y="2466926"/>
            <a:ext cx="1517573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E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tc)</a:t>
            </a:r>
          </a:p>
        </p:txBody>
      </p:sp>
      <p:pic>
        <p:nvPicPr>
          <p:cNvPr id="10" name="图片 9" descr="trnF_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023888" y="132954"/>
            <a:ext cx="2170800" cy="2337622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10362511" y="2467167"/>
            <a:ext cx="1768419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F_1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gaa)</a:t>
            </a:r>
          </a:p>
        </p:txBody>
      </p:sp>
      <p:pic>
        <p:nvPicPr>
          <p:cNvPr id="12" name="图片 11" descr="trnF_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283253" y="132704"/>
            <a:ext cx="2170800" cy="2337622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12736195" y="2470150"/>
            <a:ext cx="13931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F_2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aaa)</a:t>
            </a:r>
          </a:p>
        </p:txBody>
      </p:sp>
      <p:pic>
        <p:nvPicPr>
          <p:cNvPr id="14" name="图片 13" descr="trnH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299362" y="2815818"/>
            <a:ext cx="2170800" cy="2337622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3801110" y="5153025"/>
            <a:ext cx="86423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rnH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(gtg)</a:t>
            </a:r>
            <a:endParaRPr lang="zh-CN" altLang="en-US" sz="1400"/>
          </a:p>
        </p:txBody>
      </p:sp>
      <p:pic>
        <p:nvPicPr>
          <p:cNvPr id="16" name="图片 15" descr="trnG_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600640" y="93969"/>
            <a:ext cx="2206800" cy="2376389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15001391" y="2470342"/>
            <a:ext cx="1768419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rnG_1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(tcc)</a:t>
            </a:r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18" name="图片 17" descr="trnG_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93588" y="2804149"/>
            <a:ext cx="2170800" cy="2337622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1503680" y="5183505"/>
            <a:ext cx="102171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rnG_2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(tcc)</a:t>
            </a:r>
            <a:endParaRPr lang="zh-CN" altLang="en-US" sz="1400"/>
          </a:p>
        </p:txBody>
      </p:sp>
      <p:pic>
        <p:nvPicPr>
          <p:cNvPr id="20" name="图片 19" descr="trnI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554941" y="2796779"/>
            <a:ext cx="2170800" cy="2337622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6010426" y="5153217"/>
            <a:ext cx="1768419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I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gat)</a:t>
            </a:r>
          </a:p>
        </p:txBody>
      </p:sp>
      <p:pic>
        <p:nvPicPr>
          <p:cNvPr id="22" name="图片 21" descr="trnK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802256" y="2773919"/>
            <a:ext cx="2170800" cy="2337622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8203454" y="5111307"/>
            <a:ext cx="1768419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K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tt)</a:t>
            </a:r>
          </a:p>
        </p:txBody>
      </p:sp>
      <p:pic>
        <p:nvPicPr>
          <p:cNvPr id="24" name="图片 23" descr="trnM_1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0023888" y="2773913"/>
            <a:ext cx="2170800" cy="2337466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>
            <a:off x="10362565" y="5111115"/>
            <a:ext cx="148526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M_1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cat)</a:t>
            </a:r>
          </a:p>
        </p:txBody>
      </p:sp>
      <p:pic>
        <p:nvPicPr>
          <p:cNvPr id="26" name="图片 25" descr="trnM_2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2283723" y="2796773"/>
            <a:ext cx="2170800" cy="2337825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12736195" y="5153025"/>
            <a:ext cx="123634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M_2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cat)</a:t>
            </a:r>
          </a:p>
        </p:txBody>
      </p:sp>
      <p:pic>
        <p:nvPicPr>
          <p:cNvPr id="28" name="图片 27" descr="trnM_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4489009" y="2815818"/>
            <a:ext cx="2170800" cy="2337622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15085695" y="5153025"/>
            <a:ext cx="123634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M_3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cat)</a:t>
            </a:r>
          </a:p>
        </p:txBody>
      </p:sp>
      <p:pic>
        <p:nvPicPr>
          <p:cNvPr id="30" name="图片 29" descr="trnL_1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128270" y="5459969"/>
            <a:ext cx="2170800" cy="2337694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1530985" y="7797165"/>
            <a:ext cx="119253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L_1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aa)</a:t>
            </a:r>
          </a:p>
        </p:txBody>
      </p:sp>
      <p:pic>
        <p:nvPicPr>
          <p:cNvPr id="32" name="图片 31" descr="trnL_2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299743" y="5459969"/>
            <a:ext cx="2170800" cy="2337622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3809365" y="7797165"/>
            <a:ext cx="119253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L_2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ag)</a:t>
            </a:r>
          </a:p>
        </p:txBody>
      </p:sp>
      <p:pic>
        <p:nvPicPr>
          <p:cNvPr id="34" name="图片 33" descr="trnN_1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554855" y="5459969"/>
            <a:ext cx="2170800" cy="2337622"/>
          </a:xfrm>
          <a:prstGeom prst="rect">
            <a:avLst/>
          </a:prstGeom>
        </p:spPr>
      </p:pic>
      <p:sp>
        <p:nvSpPr>
          <p:cNvPr id="35" name="文本框 34"/>
          <p:cNvSpPr txBox="1"/>
          <p:nvPr/>
        </p:nvSpPr>
        <p:spPr>
          <a:xfrm>
            <a:off x="6010275" y="7797165"/>
            <a:ext cx="108712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N_1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att)</a:t>
            </a:r>
          </a:p>
        </p:txBody>
      </p:sp>
      <p:pic>
        <p:nvPicPr>
          <p:cNvPr id="36" name="图片 35" descr="trnN_2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7726259" y="5459719"/>
            <a:ext cx="2170800" cy="2337622"/>
          </a:xfrm>
          <a:prstGeom prst="rect">
            <a:avLst/>
          </a:prstGeom>
        </p:spPr>
      </p:pic>
      <p:sp>
        <p:nvSpPr>
          <p:cNvPr id="37" name="文本框 36"/>
          <p:cNvSpPr txBox="1"/>
          <p:nvPr/>
        </p:nvSpPr>
        <p:spPr>
          <a:xfrm>
            <a:off x="8203565" y="7797165"/>
            <a:ext cx="11055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N_2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gtt)</a:t>
            </a:r>
          </a:p>
        </p:txBody>
      </p:sp>
      <p:pic>
        <p:nvPicPr>
          <p:cNvPr id="38" name="图片 37" descr="trnP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0024121" y="5459963"/>
            <a:ext cx="2170800" cy="2337540"/>
          </a:xfrm>
          <a:prstGeom prst="rect">
            <a:avLst/>
          </a:prstGeom>
        </p:spPr>
      </p:pic>
      <p:sp>
        <p:nvSpPr>
          <p:cNvPr id="39" name="文本框 38"/>
          <p:cNvSpPr txBox="1"/>
          <p:nvPr/>
        </p:nvSpPr>
        <p:spPr>
          <a:xfrm>
            <a:off x="10362565" y="7797165"/>
            <a:ext cx="10356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P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gg)</a:t>
            </a:r>
          </a:p>
        </p:txBody>
      </p:sp>
      <p:pic>
        <p:nvPicPr>
          <p:cNvPr id="40" name="图片 39" descr="trnQ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2283315" y="5459719"/>
            <a:ext cx="2170800" cy="2337622"/>
          </a:xfrm>
          <a:prstGeom prst="rect">
            <a:avLst/>
          </a:prstGeom>
        </p:spPr>
      </p:pic>
      <p:sp>
        <p:nvSpPr>
          <p:cNvPr id="41" name="文本框 40"/>
          <p:cNvSpPr txBox="1"/>
          <p:nvPr/>
        </p:nvSpPr>
        <p:spPr>
          <a:xfrm>
            <a:off x="12736195" y="7797165"/>
            <a:ext cx="9182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Q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tg)</a:t>
            </a:r>
          </a:p>
        </p:txBody>
      </p:sp>
      <p:pic>
        <p:nvPicPr>
          <p:cNvPr id="42" name="图片 41" descr="trnT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7725920" y="8111525"/>
            <a:ext cx="2170800" cy="2337688"/>
          </a:xfrm>
          <a:prstGeom prst="rect">
            <a:avLst/>
          </a:prstGeom>
        </p:spPr>
      </p:pic>
      <p:sp>
        <p:nvSpPr>
          <p:cNvPr id="43" name="文本框 42"/>
          <p:cNvSpPr txBox="1"/>
          <p:nvPr/>
        </p:nvSpPr>
        <p:spPr>
          <a:xfrm>
            <a:off x="8261985" y="10448925"/>
            <a:ext cx="8947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T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gt)</a:t>
            </a:r>
          </a:p>
        </p:txBody>
      </p:sp>
      <p:pic>
        <p:nvPicPr>
          <p:cNvPr id="44" name="图片 43" descr="trnR_1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4636017" y="5437109"/>
            <a:ext cx="2170800" cy="2337622"/>
          </a:xfrm>
          <a:prstGeom prst="rect">
            <a:avLst/>
          </a:prstGeom>
        </p:spPr>
      </p:pic>
      <p:sp>
        <p:nvSpPr>
          <p:cNvPr id="45" name="文本框 44"/>
          <p:cNvSpPr txBox="1"/>
          <p:nvPr/>
        </p:nvSpPr>
        <p:spPr>
          <a:xfrm>
            <a:off x="15038705" y="7774305"/>
            <a:ext cx="14389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R_1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acg)</a:t>
            </a:r>
          </a:p>
        </p:txBody>
      </p:sp>
      <p:pic>
        <p:nvPicPr>
          <p:cNvPr id="46" name="图片 45" descr="trnR_2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042046" y="8104109"/>
            <a:ext cx="2170800" cy="2337622"/>
          </a:xfrm>
          <a:prstGeom prst="rect">
            <a:avLst/>
          </a:prstGeom>
        </p:spPr>
      </p:pic>
      <p:sp>
        <p:nvSpPr>
          <p:cNvPr id="47" name="文本框 46"/>
          <p:cNvSpPr txBox="1"/>
          <p:nvPr/>
        </p:nvSpPr>
        <p:spPr>
          <a:xfrm>
            <a:off x="1534160" y="10441305"/>
            <a:ext cx="12261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R_2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ct)</a:t>
            </a:r>
          </a:p>
        </p:txBody>
      </p:sp>
      <p:pic>
        <p:nvPicPr>
          <p:cNvPr id="48" name="图片 47" descr="trnS_1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266977" y="8103859"/>
            <a:ext cx="2170800" cy="2337622"/>
          </a:xfrm>
          <a:prstGeom prst="rect">
            <a:avLst/>
          </a:prstGeom>
        </p:spPr>
      </p:pic>
      <p:sp>
        <p:nvSpPr>
          <p:cNvPr id="49" name="文本框 48"/>
          <p:cNvSpPr txBox="1"/>
          <p:nvPr/>
        </p:nvSpPr>
        <p:spPr>
          <a:xfrm>
            <a:off x="3715385" y="10441305"/>
            <a:ext cx="12877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S_1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gct)</a:t>
            </a:r>
          </a:p>
        </p:txBody>
      </p:sp>
      <p:pic>
        <p:nvPicPr>
          <p:cNvPr id="51" name="图片 50" descr="trnS_2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507569" y="8104109"/>
            <a:ext cx="2170800" cy="2337622"/>
          </a:xfrm>
          <a:prstGeom prst="rect">
            <a:avLst/>
          </a:prstGeom>
        </p:spPr>
      </p:pic>
      <p:sp>
        <p:nvSpPr>
          <p:cNvPr id="52" name="文本框 51"/>
          <p:cNvSpPr txBox="1"/>
          <p:nvPr/>
        </p:nvSpPr>
        <p:spPr>
          <a:xfrm>
            <a:off x="5913120" y="10441305"/>
            <a:ext cx="11684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S_2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ga)</a:t>
            </a:r>
          </a:p>
        </p:txBody>
      </p:sp>
      <p:pic>
        <p:nvPicPr>
          <p:cNvPr id="53" name="图片 52" descr="trnV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0019948" y="8104058"/>
            <a:ext cx="2170800" cy="2337622"/>
          </a:xfrm>
          <a:prstGeom prst="rect">
            <a:avLst/>
          </a:prstGeom>
        </p:spPr>
      </p:pic>
      <p:sp>
        <p:nvSpPr>
          <p:cNvPr id="54" name="文本框 53"/>
          <p:cNvSpPr txBox="1"/>
          <p:nvPr/>
        </p:nvSpPr>
        <p:spPr>
          <a:xfrm>
            <a:off x="10362565" y="10441305"/>
            <a:ext cx="9658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V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ac)</a:t>
            </a:r>
          </a:p>
        </p:txBody>
      </p:sp>
      <p:pic>
        <p:nvPicPr>
          <p:cNvPr id="55" name="图片 54" descr="trnW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12283253" y="8104109"/>
            <a:ext cx="2170800" cy="2337622"/>
          </a:xfrm>
          <a:prstGeom prst="rect">
            <a:avLst/>
          </a:prstGeom>
        </p:spPr>
      </p:pic>
      <p:sp>
        <p:nvSpPr>
          <p:cNvPr id="56" name="文本框 55"/>
          <p:cNvSpPr txBox="1"/>
          <p:nvPr/>
        </p:nvSpPr>
        <p:spPr>
          <a:xfrm>
            <a:off x="12736195" y="10441305"/>
            <a:ext cx="121412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W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tca)</a:t>
            </a:r>
          </a:p>
        </p:txBody>
      </p:sp>
      <p:pic>
        <p:nvPicPr>
          <p:cNvPr id="57" name="图片 56" descr="trnY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4488880" y="8104109"/>
            <a:ext cx="2170800" cy="2337622"/>
          </a:xfrm>
          <a:prstGeom prst="rect">
            <a:avLst/>
          </a:prstGeom>
        </p:spPr>
      </p:pic>
      <p:sp>
        <p:nvSpPr>
          <p:cNvPr id="58" name="文本框 57"/>
          <p:cNvSpPr txBox="1"/>
          <p:nvPr/>
        </p:nvSpPr>
        <p:spPr>
          <a:xfrm>
            <a:off x="14990445" y="10441305"/>
            <a:ext cx="12674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trnY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(gta)</a:t>
            </a:r>
          </a:p>
        </p:txBody>
      </p:sp>
      <p:sp>
        <p:nvSpPr>
          <p:cNvPr id="59" name="文本框 58"/>
          <p:cNvSpPr txBox="1"/>
          <p:nvPr/>
        </p:nvSpPr>
        <p:spPr>
          <a:xfrm>
            <a:off x="3292475" y="11171555"/>
            <a:ext cx="111309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zh-CN" altLang="en-US" b="1" dirty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ure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 b="1" dirty="0">
                <a:latin typeface="Times New Roman" panose="02020603050405020304" charset="0"/>
                <a:cs typeface="Times New Roman" panose="02020603050405020304" charset="0"/>
              </a:rPr>
              <a:t>S1. Secondary structure of tRNA genes </a:t>
            </a:r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</a:rPr>
              <a:t>encoded </a:t>
            </a:r>
            <a:r>
              <a:rPr lang="zh-CN" altLang="en-US" b="1" dirty="0">
                <a:latin typeface="Times New Roman" panose="02020603050405020304" charset="0"/>
                <a:cs typeface="Times New Roman" panose="02020603050405020304" charset="0"/>
              </a:rPr>
              <a:t>in the </a:t>
            </a:r>
            <a:r>
              <a:rPr lang="zh-CN" altLang="en-US" b="1" i="1" dirty="0">
                <a:latin typeface="Times New Roman" panose="02020603050405020304" charset="0"/>
                <a:cs typeface="Times New Roman" panose="02020603050405020304" charset="0"/>
              </a:rPr>
              <a:t>S. chartarum</a:t>
            </a:r>
            <a:r>
              <a:rPr lang="zh-CN" altLang="en-US" b="1" dirty="0">
                <a:latin typeface="Times New Roman" panose="02020603050405020304" charset="0"/>
                <a:cs typeface="Times New Roman" panose="02020603050405020304" charset="0"/>
              </a:rPr>
              <a:t> mitogenome. 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6</Words>
  <Application>Microsoft Office PowerPoint</Application>
  <PresentationFormat>Custom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Wingdings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MDPI</cp:lastModifiedBy>
  <cp:revision>197</cp:revision>
  <dcterms:created xsi:type="dcterms:W3CDTF">2019-06-19T02:08:00Z</dcterms:created>
  <dcterms:modified xsi:type="dcterms:W3CDTF">2021-12-12T06:49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